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yavooLab\Desktop\Jay\cytotoxicity%20ACH2%20Jlat%208301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yavooLab\Desktop\Jay\cytotoxicity%20ACH2%20Jlat%208301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664E-2"/>
          <c:y val="5.0925925925925923E-2"/>
          <c:w val="0.83402551425257887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1 (2)'!$G$13</c:f>
              <c:strCache>
                <c:ptCount val="1"/>
                <c:pt idx="0">
                  <c:v>FL10.6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2)'!$K$14:$K$17</c:f>
                <c:numCache>
                  <c:formatCode>General</c:formatCode>
                  <c:ptCount val="4"/>
                  <c:pt idx="0">
                    <c:v>5.0999999999999996</c:v>
                  </c:pt>
                  <c:pt idx="1">
                    <c:v>4.9000000000000004</c:v>
                  </c:pt>
                  <c:pt idx="2">
                    <c:v>5.4</c:v>
                  </c:pt>
                  <c:pt idx="3">
                    <c:v>6.6</c:v>
                  </c:pt>
                </c:numCache>
              </c:numRef>
            </c:plus>
            <c:minus>
              <c:numRef>
                <c:f>'Sheet1 (2)'!$K$14:$K$17</c:f>
                <c:numCache>
                  <c:formatCode>General</c:formatCode>
                  <c:ptCount val="4"/>
                  <c:pt idx="0">
                    <c:v>5.0999999999999996</c:v>
                  </c:pt>
                  <c:pt idx="1">
                    <c:v>4.9000000000000004</c:v>
                  </c:pt>
                  <c:pt idx="2">
                    <c:v>5.4</c:v>
                  </c:pt>
                  <c:pt idx="3">
                    <c:v>6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F$14:$F$17</c:f>
              <c:strCache>
                <c:ptCount val="4"/>
                <c:pt idx="0">
                  <c:v>Rottlerin 50</c:v>
                </c:pt>
                <c:pt idx="1">
                  <c:v>Rottlerin 25</c:v>
                </c:pt>
                <c:pt idx="2">
                  <c:v>Rottlerin 12.5</c:v>
                </c:pt>
                <c:pt idx="3">
                  <c:v>Rottlerin 6.25</c:v>
                </c:pt>
              </c:strCache>
            </c:strRef>
          </c:cat>
          <c:val>
            <c:numRef>
              <c:f>'Sheet1 (2)'!$G$14:$G$17</c:f>
              <c:numCache>
                <c:formatCode>General</c:formatCode>
                <c:ptCount val="4"/>
                <c:pt idx="0">
                  <c:v>54.074072200000003</c:v>
                </c:pt>
                <c:pt idx="1">
                  <c:v>71.087146000000004</c:v>
                </c:pt>
                <c:pt idx="2">
                  <c:v>90.99466799999999</c:v>
                </c:pt>
                <c:pt idx="3">
                  <c:v>89.649547999999996</c:v>
                </c:pt>
              </c:numCache>
            </c:numRef>
          </c:val>
        </c:ser>
        <c:ser>
          <c:idx val="1"/>
          <c:order val="1"/>
          <c:tx>
            <c:strRef>
              <c:f>'Sheet1 (2)'!$H$13</c:f>
              <c:strCache>
                <c:ptCount val="1"/>
                <c:pt idx="0">
                  <c:v>TGA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2)'!$L$14:$L$17</c:f>
                <c:numCache>
                  <c:formatCode>General</c:formatCode>
                  <c:ptCount val="4"/>
                  <c:pt idx="0">
                    <c:v>7.3</c:v>
                  </c:pt>
                  <c:pt idx="1">
                    <c:v>5.8</c:v>
                  </c:pt>
                  <c:pt idx="2">
                    <c:v>7.4</c:v>
                  </c:pt>
                  <c:pt idx="3">
                    <c:v>8.4</c:v>
                  </c:pt>
                </c:numCache>
              </c:numRef>
            </c:plus>
            <c:minus>
              <c:numRef>
                <c:f>'Sheet1 (2)'!$L$14:$L$17</c:f>
                <c:numCache>
                  <c:formatCode>General</c:formatCode>
                  <c:ptCount val="4"/>
                  <c:pt idx="0">
                    <c:v>7.3</c:v>
                  </c:pt>
                  <c:pt idx="1">
                    <c:v>5.8</c:v>
                  </c:pt>
                  <c:pt idx="2">
                    <c:v>7.4</c:v>
                  </c:pt>
                  <c:pt idx="3">
                    <c:v>8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F$14:$F$17</c:f>
              <c:strCache>
                <c:ptCount val="4"/>
                <c:pt idx="0">
                  <c:v>Rottlerin 50</c:v>
                </c:pt>
                <c:pt idx="1">
                  <c:v>Rottlerin 25</c:v>
                </c:pt>
                <c:pt idx="2">
                  <c:v>Rottlerin 12.5</c:v>
                </c:pt>
                <c:pt idx="3">
                  <c:v>Rottlerin 6.25</c:v>
                </c:pt>
              </c:strCache>
            </c:strRef>
          </c:cat>
          <c:val>
            <c:numRef>
              <c:f>'Sheet1 (2)'!$H$14:$H$17</c:f>
              <c:numCache>
                <c:formatCode>General</c:formatCode>
                <c:ptCount val="4"/>
                <c:pt idx="0">
                  <c:v>58.863318700000001</c:v>
                </c:pt>
                <c:pt idx="1">
                  <c:v>72.982046000000011</c:v>
                </c:pt>
                <c:pt idx="2">
                  <c:v>85.264667999999986</c:v>
                </c:pt>
                <c:pt idx="3">
                  <c:v>93.445781999999994</c:v>
                </c:pt>
              </c:numCache>
            </c:numRef>
          </c:val>
        </c:ser>
        <c:ser>
          <c:idx val="2"/>
          <c:order val="2"/>
          <c:tx>
            <c:strRef>
              <c:f>'Sheet1 (2)'!$I$13</c:f>
              <c:strCache>
                <c:ptCount val="1"/>
                <c:pt idx="0">
                  <c:v>TGA2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2)'!$M$14:$M$17</c:f>
                <c:numCache>
                  <c:formatCode>General</c:formatCode>
                  <c:ptCount val="4"/>
                  <c:pt idx="0">
                    <c:v>4.5999999999999996</c:v>
                  </c:pt>
                  <c:pt idx="1">
                    <c:v>7.2</c:v>
                  </c:pt>
                  <c:pt idx="2">
                    <c:v>4.5999999999999996</c:v>
                  </c:pt>
                  <c:pt idx="3">
                    <c:v>5.3</c:v>
                  </c:pt>
                </c:numCache>
              </c:numRef>
            </c:plus>
            <c:minus>
              <c:numRef>
                <c:f>'Sheet1 (2)'!$M$14:$M$17</c:f>
                <c:numCache>
                  <c:formatCode>General</c:formatCode>
                  <c:ptCount val="4"/>
                  <c:pt idx="0">
                    <c:v>4.5999999999999996</c:v>
                  </c:pt>
                  <c:pt idx="1">
                    <c:v>7.2</c:v>
                  </c:pt>
                  <c:pt idx="2">
                    <c:v>4.5999999999999996</c:v>
                  </c:pt>
                  <c:pt idx="3">
                    <c:v>5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F$14:$F$17</c:f>
              <c:strCache>
                <c:ptCount val="4"/>
                <c:pt idx="0">
                  <c:v>Rottlerin 50</c:v>
                </c:pt>
                <c:pt idx="1">
                  <c:v>Rottlerin 25</c:v>
                </c:pt>
                <c:pt idx="2">
                  <c:v>Rottlerin 12.5</c:v>
                </c:pt>
                <c:pt idx="3">
                  <c:v>Rottlerin 6.25</c:v>
                </c:pt>
              </c:strCache>
            </c:strRef>
          </c:cat>
          <c:val>
            <c:numRef>
              <c:f>'Sheet1 (2)'!$I$14:$I$17</c:f>
              <c:numCache>
                <c:formatCode>General</c:formatCode>
                <c:ptCount val="4"/>
                <c:pt idx="0">
                  <c:v>53.966118700000003</c:v>
                </c:pt>
                <c:pt idx="1">
                  <c:v>69.68364600000001</c:v>
                </c:pt>
                <c:pt idx="2">
                  <c:v>89.15740799999999</c:v>
                </c:pt>
                <c:pt idx="3">
                  <c:v>90.461081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125163912"/>
        <c:axId val="125166344"/>
      </c:barChart>
      <c:catAx>
        <c:axId val="125163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5166344"/>
        <c:crosses val="autoZero"/>
        <c:auto val="1"/>
        <c:lblAlgn val="ctr"/>
        <c:lblOffset val="100"/>
        <c:noMultiLvlLbl val="0"/>
      </c:catAx>
      <c:valAx>
        <c:axId val="125166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51639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1456496062992125"/>
          <c:y val="5.8737605715952171E-2"/>
          <c:w val="0.32623451138375142"/>
          <c:h val="0.244812289088863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47594050743664E-2"/>
          <c:y val="5.0925925925925923E-2"/>
          <c:w val="0.83402551425257887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1 (3)'!$G$13</c:f>
              <c:strCache>
                <c:ptCount val="1"/>
                <c:pt idx="0">
                  <c:v>FL10.6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3)'!$K$20:$K$23</c:f>
                <c:numCache>
                  <c:formatCode>General</c:formatCode>
                  <c:ptCount val="4"/>
                  <c:pt idx="0">
                    <c:v>7.3</c:v>
                  </c:pt>
                  <c:pt idx="1">
                    <c:v>6.1</c:v>
                  </c:pt>
                  <c:pt idx="2">
                    <c:v>7.4</c:v>
                  </c:pt>
                  <c:pt idx="3">
                    <c:v>5.6</c:v>
                  </c:pt>
                </c:numCache>
              </c:numRef>
            </c:plus>
            <c:minus>
              <c:numRef>
                <c:f>'Sheet1 (3)'!$K$20:$K$23</c:f>
                <c:numCache>
                  <c:formatCode>General</c:formatCode>
                  <c:ptCount val="4"/>
                  <c:pt idx="0">
                    <c:v>7.3</c:v>
                  </c:pt>
                  <c:pt idx="1">
                    <c:v>6.1</c:v>
                  </c:pt>
                  <c:pt idx="2">
                    <c:v>7.4</c:v>
                  </c:pt>
                  <c:pt idx="3">
                    <c:v>5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3)'!$F$20:$F$23</c:f>
              <c:strCache>
                <c:ptCount val="4"/>
                <c:pt idx="0">
                  <c:v>WP1066 5</c:v>
                </c:pt>
                <c:pt idx="1">
                  <c:v>WP1066 2.5</c:v>
                </c:pt>
                <c:pt idx="2">
                  <c:v>WP1066 1.25</c:v>
                </c:pt>
                <c:pt idx="3">
                  <c:v>WP1066 0.625</c:v>
                </c:pt>
              </c:strCache>
            </c:strRef>
          </c:cat>
          <c:val>
            <c:numRef>
              <c:f>'Sheet1 (3)'!$G$20:$G$23</c:f>
              <c:numCache>
                <c:formatCode>General</c:formatCode>
                <c:ptCount val="4"/>
                <c:pt idx="0">
                  <c:v>66.665588700000001</c:v>
                </c:pt>
                <c:pt idx="1">
                  <c:v>86.520495800000006</c:v>
                </c:pt>
                <c:pt idx="2">
                  <c:v>94.834266999999997</c:v>
                </c:pt>
                <c:pt idx="3">
                  <c:v>98.959128000000007</c:v>
                </c:pt>
              </c:numCache>
            </c:numRef>
          </c:val>
        </c:ser>
        <c:ser>
          <c:idx val="1"/>
          <c:order val="1"/>
          <c:tx>
            <c:strRef>
              <c:f>'Sheet1 (3)'!$H$13</c:f>
              <c:strCache>
                <c:ptCount val="1"/>
                <c:pt idx="0">
                  <c:v>TGA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3)'!$L$20:$L$23</c:f>
                <c:numCache>
                  <c:formatCode>General</c:formatCode>
                  <c:ptCount val="4"/>
                  <c:pt idx="0">
                    <c:v>7.1</c:v>
                  </c:pt>
                  <c:pt idx="1">
                    <c:v>5.3</c:v>
                  </c:pt>
                  <c:pt idx="2">
                    <c:v>6.2</c:v>
                  </c:pt>
                  <c:pt idx="3">
                    <c:v>3.7</c:v>
                  </c:pt>
                </c:numCache>
              </c:numRef>
            </c:plus>
            <c:minus>
              <c:numRef>
                <c:f>'Sheet1 (3)'!$L$20:$L$23</c:f>
                <c:numCache>
                  <c:formatCode>General</c:formatCode>
                  <c:ptCount val="4"/>
                  <c:pt idx="0">
                    <c:v>7.1</c:v>
                  </c:pt>
                  <c:pt idx="1">
                    <c:v>5.3</c:v>
                  </c:pt>
                  <c:pt idx="2">
                    <c:v>6.2</c:v>
                  </c:pt>
                  <c:pt idx="3">
                    <c:v>3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3)'!$F$20:$F$23</c:f>
              <c:strCache>
                <c:ptCount val="4"/>
                <c:pt idx="0">
                  <c:v>WP1066 5</c:v>
                </c:pt>
                <c:pt idx="1">
                  <c:v>WP1066 2.5</c:v>
                </c:pt>
                <c:pt idx="2">
                  <c:v>WP1066 1.25</c:v>
                </c:pt>
                <c:pt idx="3">
                  <c:v>WP1066 0.625</c:v>
                </c:pt>
              </c:strCache>
            </c:strRef>
          </c:cat>
          <c:val>
            <c:numRef>
              <c:f>'Sheet1 (3)'!$H$20:$H$23</c:f>
              <c:numCache>
                <c:formatCode>General</c:formatCode>
                <c:ptCount val="4"/>
                <c:pt idx="0">
                  <c:v>60.925788699999998</c:v>
                </c:pt>
                <c:pt idx="1">
                  <c:v>82.623372310000008</c:v>
                </c:pt>
                <c:pt idx="2">
                  <c:v>91.936866999999992</c:v>
                </c:pt>
                <c:pt idx="3">
                  <c:v>96.195728000000003</c:v>
                </c:pt>
              </c:numCache>
            </c:numRef>
          </c:val>
        </c:ser>
        <c:ser>
          <c:idx val="2"/>
          <c:order val="2"/>
          <c:tx>
            <c:strRef>
              <c:f>'Sheet1 (3)'!$I$13</c:f>
              <c:strCache>
                <c:ptCount val="1"/>
                <c:pt idx="0">
                  <c:v>TGA2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1 (3)'!$M$20:$M$23</c:f>
                <c:numCache>
                  <c:formatCode>General</c:formatCode>
                  <c:ptCount val="4"/>
                  <c:pt idx="0">
                    <c:v>5.8</c:v>
                  </c:pt>
                  <c:pt idx="1">
                    <c:v>6.4</c:v>
                  </c:pt>
                  <c:pt idx="2">
                    <c:v>4.3</c:v>
                  </c:pt>
                  <c:pt idx="3">
                    <c:v>5.2</c:v>
                  </c:pt>
                </c:numCache>
              </c:numRef>
            </c:plus>
            <c:minus>
              <c:numRef>
                <c:f>'Sheet1 (3)'!$M$20:$M$23</c:f>
                <c:numCache>
                  <c:formatCode>General</c:formatCode>
                  <c:ptCount val="4"/>
                  <c:pt idx="0">
                    <c:v>5.8</c:v>
                  </c:pt>
                  <c:pt idx="1">
                    <c:v>6.4</c:v>
                  </c:pt>
                  <c:pt idx="2">
                    <c:v>4.3</c:v>
                  </c:pt>
                  <c:pt idx="3">
                    <c:v>5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3)'!$F$20:$F$23</c:f>
              <c:strCache>
                <c:ptCount val="4"/>
                <c:pt idx="0">
                  <c:v>WP1066 5</c:v>
                </c:pt>
                <c:pt idx="1">
                  <c:v>WP1066 2.5</c:v>
                </c:pt>
                <c:pt idx="2">
                  <c:v>WP1066 1.25</c:v>
                </c:pt>
                <c:pt idx="3">
                  <c:v>WP1066 0.625</c:v>
                </c:pt>
              </c:strCache>
            </c:strRef>
          </c:cat>
          <c:val>
            <c:numRef>
              <c:f>'Sheet1 (3)'!$I$20:$I$23</c:f>
              <c:numCache>
                <c:formatCode>General</c:formatCode>
                <c:ptCount val="4"/>
                <c:pt idx="0">
                  <c:v>56.051226700000001</c:v>
                </c:pt>
                <c:pt idx="1">
                  <c:v>76.324972310000007</c:v>
                </c:pt>
                <c:pt idx="2">
                  <c:v>88.044126999999989</c:v>
                </c:pt>
                <c:pt idx="3">
                  <c:v>99.180428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124795912"/>
        <c:axId val="124800392"/>
      </c:barChart>
      <c:catAx>
        <c:axId val="124795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800392"/>
        <c:crosses val="autoZero"/>
        <c:auto val="1"/>
        <c:lblAlgn val="ctr"/>
        <c:lblOffset val="100"/>
        <c:noMultiLvlLbl val="0"/>
      </c:catAx>
      <c:valAx>
        <c:axId val="124800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47959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0623162729658793"/>
          <c:y val="6.3367235345581807E-2"/>
          <c:w val="0.35655893304034669"/>
          <c:h val="0.239998359580052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4327192"/>
              </p:ext>
            </p:extLst>
          </p:nvPr>
        </p:nvGraphicFramePr>
        <p:xfrm>
          <a:off x="609600" y="748100"/>
          <a:ext cx="32766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8155475"/>
              </p:ext>
            </p:extLst>
          </p:nvPr>
        </p:nvGraphicFramePr>
        <p:xfrm>
          <a:off x="4953000" y="748100"/>
          <a:ext cx="32766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219200" y="4862900"/>
            <a:ext cx="2619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         12.5       6.25      3.12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28600" y="4634300"/>
            <a:ext cx="9204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ottleri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38800" y="4862900"/>
            <a:ext cx="2520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         2.5        1.25      0.62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572000" y="4634300"/>
            <a:ext cx="96847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P 1066 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ight Triangle 11"/>
          <p:cNvSpPr/>
          <p:nvPr/>
        </p:nvSpPr>
        <p:spPr>
          <a:xfrm>
            <a:off x="1219200" y="4710501"/>
            <a:ext cx="2514600" cy="152400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Triangle 12"/>
          <p:cNvSpPr/>
          <p:nvPr/>
        </p:nvSpPr>
        <p:spPr>
          <a:xfrm>
            <a:off x="5562600" y="4710501"/>
            <a:ext cx="2514600" cy="152400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55332" y="138500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61628" y="138500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848600" y="76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357307" y="2594648"/>
            <a:ext cx="1784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Viability (%DMSO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986092" y="2594648"/>
            <a:ext cx="1784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 Viability (%DMSO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597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35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est</dc:creator>
  <cp:lastModifiedBy>AyyavooLab</cp:lastModifiedBy>
  <cp:revision>44</cp:revision>
  <dcterms:created xsi:type="dcterms:W3CDTF">2006-08-16T00:00:00Z</dcterms:created>
  <dcterms:modified xsi:type="dcterms:W3CDTF">2015-09-07T18:23:38Z</dcterms:modified>
</cp:coreProperties>
</file>